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91" d="100"/>
          <a:sy n="91" d="100"/>
        </p:scale>
        <p:origin x="186" y="7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777A7A-8EDB-4B95-AC30-23613735FA0F}" type="datetimeFigureOut">
              <a:rPr lang="zh-TW" altLang="en-US" smtClean="0"/>
              <a:t>2020/6/15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6EC7FC-194C-4457-8808-9AC6AAEC98D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084081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777A7A-8EDB-4B95-AC30-23613735FA0F}" type="datetimeFigureOut">
              <a:rPr lang="zh-TW" altLang="en-US" smtClean="0"/>
              <a:t>2020/6/15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6EC7FC-194C-4457-8808-9AC6AAEC98D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214928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777A7A-8EDB-4B95-AC30-23613735FA0F}" type="datetimeFigureOut">
              <a:rPr lang="zh-TW" altLang="en-US" smtClean="0"/>
              <a:t>2020/6/15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6EC7FC-194C-4457-8808-9AC6AAEC98D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809616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777A7A-8EDB-4B95-AC30-23613735FA0F}" type="datetimeFigureOut">
              <a:rPr lang="zh-TW" altLang="en-US" smtClean="0"/>
              <a:t>2020/6/15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6EC7FC-194C-4457-8808-9AC6AAEC98D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8532418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777A7A-8EDB-4B95-AC30-23613735FA0F}" type="datetimeFigureOut">
              <a:rPr lang="zh-TW" altLang="en-US" smtClean="0"/>
              <a:t>2020/6/15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6EC7FC-194C-4457-8808-9AC6AAEC98D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0709824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777A7A-8EDB-4B95-AC30-23613735FA0F}" type="datetimeFigureOut">
              <a:rPr lang="zh-TW" altLang="en-US" smtClean="0"/>
              <a:t>2020/6/15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6EC7FC-194C-4457-8808-9AC6AAEC98D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089622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777A7A-8EDB-4B95-AC30-23613735FA0F}" type="datetimeFigureOut">
              <a:rPr lang="zh-TW" altLang="en-US" smtClean="0"/>
              <a:t>2020/6/15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6EC7FC-194C-4457-8808-9AC6AAEC98D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9045267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777A7A-8EDB-4B95-AC30-23613735FA0F}" type="datetimeFigureOut">
              <a:rPr lang="zh-TW" altLang="en-US" smtClean="0"/>
              <a:t>2020/6/15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6EC7FC-194C-4457-8808-9AC6AAEC98D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7572576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777A7A-8EDB-4B95-AC30-23613735FA0F}" type="datetimeFigureOut">
              <a:rPr lang="zh-TW" altLang="en-US" smtClean="0"/>
              <a:t>2020/6/15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6EC7FC-194C-4457-8808-9AC6AAEC98D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050541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777A7A-8EDB-4B95-AC30-23613735FA0F}" type="datetimeFigureOut">
              <a:rPr lang="zh-TW" altLang="en-US" smtClean="0"/>
              <a:t>2020/6/15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6EC7FC-194C-4457-8808-9AC6AAEC98D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6673141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777A7A-8EDB-4B95-AC30-23613735FA0F}" type="datetimeFigureOut">
              <a:rPr lang="zh-TW" altLang="en-US" smtClean="0"/>
              <a:t>2020/6/15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6EC7FC-194C-4457-8808-9AC6AAEC98D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120239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777A7A-8EDB-4B95-AC30-23613735FA0F}" type="datetimeFigureOut">
              <a:rPr lang="zh-TW" altLang="en-US" smtClean="0"/>
              <a:t>2020/6/15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6EC7FC-194C-4457-8808-9AC6AAEC98D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0084273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物件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43477276"/>
              </p:ext>
            </p:extLst>
          </p:nvPr>
        </p:nvGraphicFramePr>
        <p:xfrm>
          <a:off x="2733231" y="346841"/>
          <a:ext cx="6253419" cy="452995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6" name="Prism Project" r:id="rId3" imgW="4014000" imgH="2907720" progId="Prism5.Document">
                  <p:embed/>
                </p:oleObj>
              </mc:Choice>
              <mc:Fallback>
                <p:oleObj name="Prism Project" r:id="rId3" imgW="4014000" imgH="290772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733231" y="346841"/>
                        <a:ext cx="6253419" cy="452995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矩形 2"/>
          <p:cNvSpPr/>
          <p:nvPr/>
        </p:nvSpPr>
        <p:spPr>
          <a:xfrm>
            <a:off x="2229565" y="5168757"/>
            <a:ext cx="8060063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TW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 S1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increased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</a:t>
            </a:r>
            <a:r>
              <a:rPr lang="en-US" altLang="zh-TW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34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human PDAC </a:t>
            </a:r>
            <a:r>
              <a:rPr lang="en-US" altLang="zh-TW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mples (cohort of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2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DAC patients</a:t>
            </a:r>
            <a:r>
              <a:rPr lang="en-US" altLang="zh-TW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was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gnificantly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lated to the downregulation of APC </a:t>
            </a:r>
            <a:r>
              <a:rPr lang="en-US" altLang="zh-TW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s. Significance test for the Pearson correlation coefficient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 was </a:t>
            </a:r>
            <a:r>
              <a:rPr lang="en-US" altLang="zh-TW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ducted,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&lt;0.05 </a:t>
            </a:r>
            <a:r>
              <a:rPr lang="en-US" altLang="zh-TW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s considered significant.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442516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8</TotalTime>
  <Words>45</Words>
  <Application>Microsoft Office PowerPoint</Application>
  <PresentationFormat>寬螢幕</PresentationFormat>
  <Paragraphs>1</Paragraphs>
  <Slides>1</Slides>
  <Notes>0</Notes>
  <HiddenSlides>0</HiddenSlides>
  <MMClips>0</MMClips>
  <ScaleCrop>false</ScaleCrop>
  <HeadingPairs>
    <vt:vector size="8" baseType="variant">
      <vt:variant>
        <vt:lpstr>使用字型</vt:lpstr>
      </vt:variant>
      <vt:variant>
        <vt:i4>5</vt:i4>
      </vt:variant>
      <vt:variant>
        <vt:lpstr>佈景主題</vt:lpstr>
      </vt:variant>
      <vt:variant>
        <vt:i4>1</vt:i4>
      </vt:variant>
      <vt:variant>
        <vt:lpstr>內嵌 OLE 伺服程式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8" baseType="lpstr">
      <vt:lpstr>新細明體</vt:lpstr>
      <vt:lpstr>Arial</vt:lpstr>
      <vt:lpstr>Calibri</vt:lpstr>
      <vt:lpstr>Calibri Light</vt:lpstr>
      <vt:lpstr>Times New Roman</vt:lpstr>
      <vt:lpstr>Office 佈景主題</vt:lpstr>
      <vt:lpstr>Prism Project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靖傑 翁</dc:creator>
  <cp:lastModifiedBy>User</cp:lastModifiedBy>
  <cp:revision>9</cp:revision>
  <dcterms:created xsi:type="dcterms:W3CDTF">2019-07-09T05:01:27Z</dcterms:created>
  <dcterms:modified xsi:type="dcterms:W3CDTF">2020-06-15T01:39:54Z</dcterms:modified>
</cp:coreProperties>
</file>